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0"/>
    <p:restoredTop sz="94599"/>
  </p:normalViewPr>
  <p:slideViewPr>
    <p:cSldViewPr snapToGrid="0" snapToObjects="1">
      <p:cViewPr>
        <p:scale>
          <a:sx n="160" d="100"/>
          <a:sy n="160" d="100"/>
        </p:scale>
        <p:origin x="1368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816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27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234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373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74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819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061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81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536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621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957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97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80504" y="1245445"/>
            <a:ext cx="5690149" cy="715347"/>
            <a:chOff x="24904" y="314112"/>
            <a:chExt cx="5690149" cy="715347"/>
          </a:xfrm>
        </p:grpSpPr>
        <p:grpSp>
          <p:nvGrpSpPr>
            <p:cNvPr id="11" name="Group 10"/>
            <p:cNvGrpSpPr/>
            <p:nvPr/>
          </p:nvGrpSpPr>
          <p:grpSpPr>
            <a:xfrm>
              <a:off x="2286739" y="320371"/>
              <a:ext cx="2931630" cy="709088"/>
              <a:chOff x="2603157" y="317158"/>
              <a:chExt cx="3355613" cy="679620"/>
            </a:xfrm>
          </p:grpSpPr>
          <p:sp>
            <p:nvSpPr>
              <p:cNvPr id="9" name="Rectangle 8"/>
              <p:cNvSpPr/>
              <p:nvPr/>
            </p:nvSpPr>
            <p:spPr>
              <a:xfrm>
                <a:off x="2603157" y="477795"/>
                <a:ext cx="238897" cy="51898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5719873" y="317158"/>
                <a:ext cx="238897" cy="51898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" name="Rectangle 11"/>
            <p:cNvSpPr/>
            <p:nvPr/>
          </p:nvSpPr>
          <p:spPr>
            <a:xfrm>
              <a:off x="24904" y="314113"/>
              <a:ext cx="48603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Calibri" charset="0"/>
                  <a:ea typeface="Calibri" charset="0"/>
                  <a:cs typeface="Calibri" charset="0"/>
                </a:rPr>
                <a:t>a. T1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2661258" y="314113"/>
              <a:ext cx="49244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Calibri" charset="0"/>
                  <a:ea typeface="Calibri" charset="0"/>
                  <a:cs typeface="Calibri" charset="0"/>
                </a:rPr>
                <a:t>b. T2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5237037" y="314112"/>
              <a:ext cx="4780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Calibri" charset="0"/>
                  <a:ea typeface="Calibri" charset="0"/>
                  <a:cs typeface="Calibri" charset="0"/>
                </a:rPr>
                <a:t>c. T3</a:t>
              </a: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493770" y="1599825"/>
            <a:ext cx="2587688" cy="1801368"/>
            <a:chOff x="431800" y="2531265"/>
            <a:chExt cx="2587688" cy="1801368"/>
          </a:xfrm>
        </p:grpSpPr>
        <p:cxnSp>
          <p:nvCxnSpPr>
            <p:cNvPr id="15" name="Straight Connector 14"/>
            <p:cNvCxnSpPr/>
            <p:nvPr/>
          </p:nvCxnSpPr>
          <p:spPr>
            <a:xfrm>
              <a:off x="431800" y="2531265"/>
              <a:ext cx="8466" cy="180136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40877" y="4332633"/>
              <a:ext cx="257861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1" name="Straight Connector 20"/>
          <p:cNvCxnSpPr/>
          <p:nvPr/>
        </p:nvCxnSpPr>
        <p:spPr>
          <a:xfrm>
            <a:off x="3134708" y="1603330"/>
            <a:ext cx="8466" cy="18013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H="1">
            <a:off x="3135932" y="3392831"/>
            <a:ext cx="2577998" cy="8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" name="Group 19"/>
          <p:cNvGrpSpPr/>
          <p:nvPr/>
        </p:nvGrpSpPr>
        <p:grpSpPr>
          <a:xfrm>
            <a:off x="5753663" y="1591463"/>
            <a:ext cx="2548429" cy="1801368"/>
            <a:chOff x="5713319" y="1591463"/>
            <a:chExt cx="2548429" cy="1801368"/>
          </a:xfrm>
        </p:grpSpPr>
        <p:cxnSp>
          <p:nvCxnSpPr>
            <p:cNvPr id="23" name="Straight Connector 22"/>
            <p:cNvCxnSpPr/>
            <p:nvPr/>
          </p:nvCxnSpPr>
          <p:spPr>
            <a:xfrm>
              <a:off x="5713319" y="1591463"/>
              <a:ext cx="8466" cy="180136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flipH="1">
              <a:off x="5722396" y="3392831"/>
              <a:ext cx="25393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33" t="12487" r="15736" b="18213"/>
          <a:stretch/>
        </p:blipFill>
        <p:spPr>
          <a:xfrm>
            <a:off x="521237" y="1745373"/>
            <a:ext cx="2526054" cy="154899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32" t="12615" r="16103" b="18343"/>
          <a:stretch/>
        </p:blipFill>
        <p:spPr>
          <a:xfrm>
            <a:off x="3168014" y="1728895"/>
            <a:ext cx="2511749" cy="1543227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06" t="12872" r="16249" b="21042"/>
          <a:stretch/>
        </p:blipFill>
        <p:spPr>
          <a:xfrm>
            <a:off x="5798941" y="1742871"/>
            <a:ext cx="2503151" cy="1477154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599564" y="2519870"/>
            <a:ext cx="649537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114300" indent="-114300">
              <a:buSzPct val="110000"/>
              <a:buFont typeface="Arial" charset="0"/>
              <a:buChar char="•"/>
            </a:pPr>
            <a:r>
              <a:rPr lang="en-US" sz="900" dirty="0"/>
              <a:t>LumA</a:t>
            </a:r>
          </a:p>
          <a:p>
            <a:pPr marL="114300" indent="-114300">
              <a:buClr>
                <a:srgbClr val="00B0F0"/>
              </a:buClr>
              <a:buSzPct val="110000"/>
              <a:buFont typeface="Arial" charset="0"/>
              <a:buChar char="•"/>
            </a:pPr>
            <a:r>
              <a:rPr lang="en-US" sz="900" dirty="0"/>
              <a:t>LumB</a:t>
            </a:r>
          </a:p>
          <a:p>
            <a:pPr marL="114300" indent="-114300">
              <a:buClr>
                <a:srgbClr val="FF0000"/>
              </a:buClr>
              <a:buSzPct val="110000"/>
              <a:buFont typeface="Arial" charset="0"/>
              <a:buChar char="•"/>
            </a:pPr>
            <a:r>
              <a:rPr lang="en-US" sz="900" dirty="0"/>
              <a:t>Basal</a:t>
            </a:r>
          </a:p>
          <a:p>
            <a:pPr marL="114300" indent="-114300">
              <a:buClr>
                <a:srgbClr val="7BD015"/>
              </a:buClr>
              <a:buSzPct val="110000"/>
              <a:buFont typeface="Arial" charset="0"/>
              <a:buChar char="•"/>
            </a:pPr>
            <a:r>
              <a:rPr lang="en-US" sz="900" dirty="0"/>
              <a:t>HER2</a:t>
            </a:r>
          </a:p>
          <a:p>
            <a:pPr marL="114300" indent="-114300">
              <a:buClr>
                <a:srgbClr val="FF40FF"/>
              </a:buClr>
              <a:buSzPct val="110000"/>
              <a:buFont typeface="Arial" charset="0"/>
              <a:buChar char="•"/>
            </a:pPr>
            <a:r>
              <a:rPr lang="en-US" sz="900" dirty="0"/>
              <a:t>Normal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61966" y="3655625"/>
            <a:ext cx="7702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.  </a:t>
            </a:r>
            <a:r>
              <a:rPr lang="en-US" sz="1200" dirty="0"/>
              <a:t>t-SNE plots showing subtype clustering of Luminal A cases in the TCGA cohort according to degree of admixture based on Distance Ratio tertile.  Luminal A cases progressively migrate towards other subtype regions, while predominantly co-clustering with Luminal B.  The pattern is similar to that observed in METABRIC</a:t>
            </a:r>
            <a:r>
              <a:rPr lang="en-US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45041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2" id="{A4401A0A-4205-9147-AAF2-7F9E0CCBC4F5}" vid="{97E13CC3-D940-C843-8AB1-B072B541D24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</TotalTime>
  <Words>41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nn, Peter</dc:creator>
  <cp:lastModifiedBy>Peter Gann</cp:lastModifiedBy>
  <cp:revision>7</cp:revision>
  <dcterms:created xsi:type="dcterms:W3CDTF">2019-02-13T16:26:51Z</dcterms:created>
  <dcterms:modified xsi:type="dcterms:W3CDTF">2019-03-01T23:45:34Z</dcterms:modified>
</cp:coreProperties>
</file>